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0" r:id="rId2"/>
    <p:sldId id="281" r:id="rId3"/>
    <p:sldId id="282" r:id="rId4"/>
    <p:sldId id="283" r:id="rId5"/>
    <p:sldId id="285" r:id="rId6"/>
    <p:sldId id="273" r:id="rId7"/>
    <p:sldId id="290" r:id="rId8"/>
    <p:sldId id="276" r:id="rId9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4660"/>
  </p:normalViewPr>
  <p:slideViewPr>
    <p:cSldViewPr snapToGrid="0">
      <p:cViewPr varScale="1">
        <p:scale>
          <a:sx n="89" d="100"/>
          <a:sy n="89" d="100"/>
        </p:scale>
        <p:origin x="1282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2C885A-8217-4485-B261-9AB0E33C476C}" type="datetimeFigureOut">
              <a:rPr lang="en-US" smtClean="0"/>
              <a:t>9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91E9A-4A0B-4C66-9AB2-4398BBD82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94232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2C885A-8217-4485-B261-9AB0E33C476C}" type="datetimeFigureOut">
              <a:rPr lang="en-US" smtClean="0"/>
              <a:t>9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91E9A-4A0B-4C66-9AB2-4398BBD82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26699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365125"/>
            <a:ext cx="1478756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365125"/>
            <a:ext cx="4321969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2C885A-8217-4485-B261-9AB0E33C476C}" type="datetimeFigureOut">
              <a:rPr lang="en-US" smtClean="0"/>
              <a:t>9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91E9A-4A0B-4C66-9AB2-4398BBD82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89618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2C885A-8217-4485-B261-9AB0E33C476C}" type="datetimeFigureOut">
              <a:rPr lang="en-US" smtClean="0"/>
              <a:t>9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91E9A-4A0B-4C66-9AB2-4398BBD82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01282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2C885A-8217-4485-B261-9AB0E33C476C}" type="datetimeFigureOut">
              <a:rPr lang="en-US" smtClean="0"/>
              <a:t>9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91E9A-4A0B-4C66-9AB2-4398BBD82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34484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7" y="1825625"/>
            <a:ext cx="2900363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1825625"/>
            <a:ext cx="2900363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2C885A-8217-4485-B261-9AB0E33C476C}" type="datetimeFigureOut">
              <a:rPr lang="en-US" smtClean="0"/>
              <a:t>9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91E9A-4A0B-4C66-9AB2-4398BBD82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67014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2C885A-8217-4485-B261-9AB0E33C476C}" type="datetimeFigureOut">
              <a:rPr lang="en-US" smtClean="0"/>
              <a:t>9/2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91E9A-4A0B-4C66-9AB2-4398BBD82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34540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2C885A-8217-4485-B261-9AB0E33C476C}" type="datetimeFigureOut">
              <a:rPr lang="en-US" smtClean="0"/>
              <a:t>9/2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91E9A-4A0B-4C66-9AB2-4398BBD82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87546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2C885A-8217-4485-B261-9AB0E33C476C}" type="datetimeFigureOut">
              <a:rPr lang="en-US" smtClean="0"/>
              <a:t>9/2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91E9A-4A0B-4C66-9AB2-4398BBD82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15805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2C885A-8217-4485-B261-9AB0E33C476C}" type="datetimeFigureOut">
              <a:rPr lang="en-US" smtClean="0"/>
              <a:t>9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91E9A-4A0B-4C66-9AB2-4398BBD82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47322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2C885A-8217-4485-B261-9AB0E33C476C}" type="datetimeFigureOut">
              <a:rPr lang="en-US" smtClean="0"/>
              <a:t>9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91E9A-4A0B-4C66-9AB2-4398BBD82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62760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2C885A-8217-4485-B261-9AB0E33C476C}" type="datetimeFigureOut">
              <a:rPr lang="en-US" smtClean="0"/>
              <a:t>9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491E9A-4A0B-4C66-9AB2-4398BBD82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21833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.png"/><Relationship Id="rId4" Type="http://schemas.microsoft.com/office/2007/relationships/hdphoto" Target="../media/hdphoto1.wdp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7" Type="http://schemas.openxmlformats.org/officeDocument/2006/relationships/image" Target="../media/image18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emf"/><Relationship Id="rId5" Type="http://schemas.openxmlformats.org/officeDocument/2006/relationships/image" Target="../media/image16.emf"/><Relationship Id="rId4" Type="http://schemas.openxmlformats.org/officeDocument/2006/relationships/image" Target="../media/image15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7" Type="http://schemas.openxmlformats.org/officeDocument/2006/relationships/image" Target="../media/image24.emf"/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emf"/><Relationship Id="rId5" Type="http://schemas.openxmlformats.org/officeDocument/2006/relationships/image" Target="../media/image22.emf"/><Relationship Id="rId4" Type="http://schemas.openxmlformats.org/officeDocument/2006/relationships/image" Target="../media/image21.emf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emf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609600" y="814514"/>
            <a:ext cx="7924800" cy="5153573"/>
            <a:chOff x="609600" y="761999"/>
            <a:chExt cx="7924800" cy="5943601"/>
          </a:xfrm>
        </p:grpSpPr>
        <p:pic>
          <p:nvPicPr>
            <p:cNvPr id="1026" name="Picture 2" descr="C:\Users\Hp\Desktop\IMG_20201224_153654.jpg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38200" y="761999"/>
              <a:ext cx="7353300" cy="305589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2" name="Group 1"/>
            <p:cNvGrpSpPr/>
            <p:nvPr/>
          </p:nvGrpSpPr>
          <p:grpSpPr>
            <a:xfrm>
              <a:off x="609600" y="3429000"/>
              <a:ext cx="7924800" cy="3276600"/>
              <a:chOff x="609600" y="3429000"/>
              <a:chExt cx="7924800" cy="3276600"/>
            </a:xfrm>
          </p:grpSpPr>
          <p:pic>
            <p:nvPicPr>
              <p:cNvPr id="3075" name="Picture 3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09600" y="4038600"/>
                <a:ext cx="3810000" cy="2667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4" name="Picture 3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648200" y="4038600"/>
                <a:ext cx="3886200" cy="2667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5" name="TextBox 4"/>
              <p:cNvSpPr txBox="1"/>
              <p:nvPr/>
            </p:nvSpPr>
            <p:spPr>
              <a:xfrm>
                <a:off x="1143000" y="3440668"/>
                <a:ext cx="4800600" cy="36933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tandard</a:t>
                </a:r>
                <a:endParaRPr 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6248400" y="3429000"/>
                <a:ext cx="1447800" cy="36933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xtract</a:t>
                </a:r>
                <a:endParaRPr 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9" name="TextBox 8"/>
          <p:cNvSpPr txBox="1"/>
          <p:nvPr/>
        </p:nvSpPr>
        <p:spPr>
          <a:xfrm>
            <a:off x="0" y="6159455"/>
            <a:ext cx="91440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.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TLC chromatogram of Gallic acid in standard and optimized extract of </a:t>
            </a:r>
            <a:r>
              <a:rPr lang="en-US" sz="16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. emblica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 254 nm.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838200" y="71057"/>
            <a:ext cx="7353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TLC analysis of Gallic acid in optimized extract of </a:t>
            </a:r>
            <a:r>
              <a:rPr lang="en-US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. emblica </a:t>
            </a:r>
            <a:endParaRPr lang="en-US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963959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869412" y="803305"/>
            <a:ext cx="7647185" cy="5460762"/>
            <a:chOff x="914400" y="369332"/>
            <a:chExt cx="7696200" cy="6398959"/>
          </a:xfrm>
        </p:grpSpPr>
        <p:pic>
          <p:nvPicPr>
            <p:cNvPr id="5122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66800" y="3886200"/>
              <a:ext cx="3657600" cy="288209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074" name="Picture 2" descr="C:\Users\Hp\Desktop\WhatsApp Image 2020-12-24 at 4.58.17 PM.jpeg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14400" y="369332"/>
              <a:ext cx="7696200" cy="34406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762500" y="3886200"/>
              <a:ext cx="3657600" cy="2844017"/>
            </a:xfrm>
            <a:prstGeom prst="rect">
              <a:avLst/>
            </a:prstGeom>
          </p:spPr>
        </p:pic>
        <p:sp>
          <p:nvSpPr>
            <p:cNvPr id="3" name="TextBox 2"/>
            <p:cNvSpPr txBox="1"/>
            <p:nvPr/>
          </p:nvSpPr>
          <p:spPr>
            <a:xfrm>
              <a:off x="1295400" y="3416594"/>
              <a:ext cx="5105399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andard</a:t>
              </a:r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6629400" y="3417348"/>
              <a:ext cx="1447800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tract</a:t>
              </a:r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" name="TextBox 4"/>
          <p:cNvSpPr txBox="1"/>
          <p:nvPr/>
        </p:nvSpPr>
        <p:spPr>
          <a:xfrm>
            <a:off x="0" y="6296603"/>
            <a:ext cx="91440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.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TLC chromatogram of Piperine in standard and optimized extract of </a:t>
            </a:r>
            <a:r>
              <a:rPr lang="en-US" sz="16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. nigrum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 254 nm. 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869412" y="70310"/>
            <a:ext cx="7647185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PTLC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of Piperine in optimized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tract of </a:t>
            </a:r>
            <a:r>
              <a:rPr 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US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igrum</a:t>
            </a:r>
            <a:endParaRPr lang="en-US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805628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953166" y="837488"/>
            <a:ext cx="7360467" cy="5272756"/>
            <a:chOff x="1021533" y="369332"/>
            <a:chExt cx="7360467" cy="6447392"/>
          </a:xfrm>
        </p:grpSpPr>
        <p:pic>
          <p:nvPicPr>
            <p:cNvPr id="2050" name="Picture 2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21533" y="4259488"/>
              <a:ext cx="3581400" cy="255723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6" name="Group 5"/>
            <p:cNvGrpSpPr/>
            <p:nvPr/>
          </p:nvGrpSpPr>
          <p:grpSpPr>
            <a:xfrm>
              <a:off x="1143000" y="369332"/>
              <a:ext cx="7239000" cy="6428531"/>
              <a:chOff x="1143000" y="369332"/>
              <a:chExt cx="7239000" cy="6428531"/>
            </a:xfrm>
          </p:grpSpPr>
          <p:pic>
            <p:nvPicPr>
              <p:cNvPr id="1026" name="Picture 2" descr="C:\Users\Hp\Desktop\IMG-20201224-WA0031.jpg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sharpenSoften amoun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143000" y="369332"/>
                <a:ext cx="7239000" cy="3593068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" name="Picture 1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4595388" y="4078587"/>
                <a:ext cx="3600639" cy="2719276"/>
              </a:xfrm>
              <a:prstGeom prst="rect">
                <a:avLst/>
              </a:prstGeom>
            </p:spPr>
          </p:pic>
          <p:sp>
            <p:nvSpPr>
              <p:cNvPr id="3" name="TextBox 2"/>
              <p:cNvSpPr txBox="1"/>
              <p:nvPr/>
            </p:nvSpPr>
            <p:spPr>
              <a:xfrm>
                <a:off x="1447800" y="3581400"/>
                <a:ext cx="5029200" cy="36933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tandard</a:t>
                </a:r>
                <a:endParaRPr 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" name="TextBox 3"/>
              <p:cNvSpPr txBox="1"/>
              <p:nvPr/>
            </p:nvSpPr>
            <p:spPr>
              <a:xfrm>
                <a:off x="6705600" y="3581400"/>
                <a:ext cx="1371600" cy="36933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xtract</a:t>
                </a:r>
                <a:endParaRPr 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5" name="TextBox 4"/>
          <p:cNvSpPr txBox="1"/>
          <p:nvPr/>
        </p:nvSpPr>
        <p:spPr>
          <a:xfrm>
            <a:off x="0" y="6181449"/>
            <a:ext cx="91440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.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TLC chromatogram of Berberine in standard and optimized extract of </a:t>
            </a:r>
            <a:r>
              <a:rPr lang="en-US" sz="16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. cordifolia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 366 nm.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1074633" y="69676"/>
            <a:ext cx="72390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PTLC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of Berberine in optimized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tract of </a:t>
            </a:r>
            <a:r>
              <a:rPr 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. cordifolia </a:t>
            </a:r>
          </a:p>
        </p:txBody>
      </p:sp>
    </p:spTree>
    <p:extLst>
      <p:ext uri="{BB962C8B-B14F-4D97-AF65-F5344CB8AC3E}">
        <p14:creationId xmlns:p14="http://schemas.microsoft.com/office/powerpoint/2010/main" val="7682927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828942" y="743484"/>
            <a:ext cx="7509300" cy="5349667"/>
            <a:chOff x="999654" y="743484"/>
            <a:chExt cx="7338588" cy="6085941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99654" y="4114800"/>
              <a:ext cx="3429000" cy="27146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2" name="Group 1"/>
            <p:cNvGrpSpPr/>
            <p:nvPr/>
          </p:nvGrpSpPr>
          <p:grpSpPr>
            <a:xfrm>
              <a:off x="999654" y="743484"/>
              <a:ext cx="7338588" cy="6085941"/>
              <a:chOff x="999654" y="743484"/>
              <a:chExt cx="7338588" cy="6085941"/>
            </a:xfrm>
          </p:grpSpPr>
          <p:pic>
            <p:nvPicPr>
              <p:cNvPr id="2050" name="Picture 2" descr="C:\Users\Hp\Desktop\IMG_20201224_154125.jpg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999654" y="743484"/>
                <a:ext cx="7338588" cy="3227215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4" name="Picture 2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724400" y="4114800"/>
                <a:ext cx="3581400" cy="271462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3" name="TextBox 2"/>
              <p:cNvSpPr txBox="1"/>
              <p:nvPr/>
            </p:nvSpPr>
            <p:spPr>
              <a:xfrm>
                <a:off x="1371600" y="3593068"/>
                <a:ext cx="4724400" cy="36933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tandard</a:t>
                </a:r>
                <a:endParaRPr 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6427018" y="3593068"/>
                <a:ext cx="1518340" cy="36933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xtract</a:t>
                </a:r>
                <a:endParaRPr 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5" name="TextBox 4"/>
          <p:cNvSpPr txBox="1"/>
          <p:nvPr/>
        </p:nvSpPr>
        <p:spPr>
          <a:xfrm>
            <a:off x="11592" y="6171652"/>
            <a:ext cx="91440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4.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TLC chromatogram of withaferin–A in standard and optimized extract of </a:t>
            </a:r>
            <a:r>
              <a:rPr lang="en-US" sz="16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. somnifera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 540 nm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828942" y="69676"/>
            <a:ext cx="748469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PTLC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W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thaferin-A in optimized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tract of </a:t>
            </a:r>
            <a:r>
              <a:rPr 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. somnifera </a:t>
            </a:r>
          </a:p>
        </p:txBody>
      </p:sp>
    </p:spTree>
    <p:extLst>
      <p:ext uri="{BB962C8B-B14F-4D97-AF65-F5344CB8AC3E}">
        <p14:creationId xmlns:p14="http://schemas.microsoft.com/office/powerpoint/2010/main" val="60846214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" y="111095"/>
            <a:ext cx="8969460" cy="6746905"/>
            <a:chOff x="76199" y="-1"/>
            <a:chExt cx="8893261" cy="6858001"/>
          </a:xfrm>
        </p:grpSpPr>
        <p:grpSp>
          <p:nvGrpSpPr>
            <p:cNvPr id="2" name="Group 1"/>
            <p:cNvGrpSpPr/>
            <p:nvPr/>
          </p:nvGrpSpPr>
          <p:grpSpPr>
            <a:xfrm>
              <a:off x="278233" y="960659"/>
              <a:ext cx="8522867" cy="2179864"/>
              <a:chOff x="278233" y="503461"/>
              <a:chExt cx="8522867" cy="2179864"/>
            </a:xfrm>
          </p:grpSpPr>
          <p:pic>
            <p:nvPicPr>
              <p:cNvPr id="11" name="Picture 10"/>
              <p:cNvPicPr>
                <a:picLocks noChangeAspect="1"/>
              </p:cNvPicPr>
              <p:nvPr/>
            </p:nvPicPr>
            <p:blipFill rotWithShape="1">
              <a:blip r:embed="rId2"/>
              <a:srcRect l="27389" t="3514" b="3958"/>
              <a:stretch/>
            </p:blipFill>
            <p:spPr>
              <a:xfrm>
                <a:off x="278233" y="503462"/>
                <a:ext cx="2731667" cy="217986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2" name="Picture 11"/>
              <p:cNvPicPr>
                <a:picLocks noChangeAspect="1"/>
              </p:cNvPicPr>
              <p:nvPr/>
            </p:nvPicPr>
            <p:blipFill rotWithShape="1">
              <a:blip r:embed="rId3"/>
              <a:srcRect l="27388" t="1732" r="3219" b="2623"/>
              <a:stretch/>
            </p:blipFill>
            <p:spPr>
              <a:xfrm>
                <a:off x="3173833" y="503461"/>
                <a:ext cx="2731667" cy="217986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3" name="Picture 12"/>
              <p:cNvPicPr>
                <a:picLocks noChangeAspect="1"/>
              </p:cNvPicPr>
              <p:nvPr/>
            </p:nvPicPr>
            <p:blipFill rotWithShape="1">
              <a:blip r:embed="rId4"/>
              <a:srcRect l="27290" t="2177" r="3707" b="2697"/>
              <a:stretch/>
            </p:blipFill>
            <p:spPr>
              <a:xfrm>
                <a:off x="6069433" y="503461"/>
                <a:ext cx="2731667" cy="217986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grpSp>
          <p:nvGrpSpPr>
            <p:cNvPr id="3" name="Group 2"/>
            <p:cNvGrpSpPr/>
            <p:nvPr/>
          </p:nvGrpSpPr>
          <p:grpSpPr>
            <a:xfrm>
              <a:off x="278232" y="3627661"/>
              <a:ext cx="8522868" cy="2179863"/>
              <a:chOff x="278232" y="3627661"/>
              <a:chExt cx="8522868" cy="2179863"/>
            </a:xfrm>
          </p:grpSpPr>
          <p:pic>
            <p:nvPicPr>
              <p:cNvPr id="14" name="Picture 13"/>
              <p:cNvPicPr>
                <a:picLocks noChangeAspect="1"/>
              </p:cNvPicPr>
              <p:nvPr/>
            </p:nvPicPr>
            <p:blipFill rotWithShape="1">
              <a:blip r:embed="rId5"/>
              <a:srcRect l="26392" t="4874" r="3046" b="3639"/>
              <a:stretch/>
            </p:blipFill>
            <p:spPr>
              <a:xfrm>
                <a:off x="278232" y="3627661"/>
                <a:ext cx="2731667" cy="217986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5" name="Picture 14"/>
              <p:cNvPicPr>
                <a:picLocks noChangeAspect="1"/>
              </p:cNvPicPr>
              <p:nvPr/>
            </p:nvPicPr>
            <p:blipFill rotWithShape="1">
              <a:blip r:embed="rId6"/>
              <a:srcRect l="26709" t="4257" r="2729" b="3217"/>
              <a:stretch/>
            </p:blipFill>
            <p:spPr>
              <a:xfrm>
                <a:off x="3173833" y="3627661"/>
                <a:ext cx="2731667" cy="217986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6" name="Picture 15"/>
              <p:cNvPicPr>
                <a:picLocks noChangeAspect="1"/>
              </p:cNvPicPr>
              <p:nvPr/>
            </p:nvPicPr>
            <p:blipFill rotWithShape="1">
              <a:blip r:embed="rId7"/>
              <a:srcRect l="26608" t="2795" r="4388" b="3119"/>
              <a:stretch/>
            </p:blipFill>
            <p:spPr>
              <a:xfrm>
                <a:off x="6069433" y="3627661"/>
                <a:ext cx="2731667" cy="217986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grpSp>
          <p:nvGrpSpPr>
            <p:cNvPr id="17" name="Group 16"/>
            <p:cNvGrpSpPr/>
            <p:nvPr/>
          </p:nvGrpSpPr>
          <p:grpSpPr>
            <a:xfrm>
              <a:off x="278232" y="457198"/>
              <a:ext cx="6336910" cy="523220"/>
              <a:chOff x="297283" y="266700"/>
              <a:chExt cx="6336910" cy="523220"/>
            </a:xfrm>
          </p:grpSpPr>
          <p:sp>
            <p:nvSpPr>
              <p:cNvPr id="18" name="TextBox 17"/>
              <p:cNvSpPr txBox="1"/>
              <p:nvPr/>
            </p:nvSpPr>
            <p:spPr>
              <a:xfrm>
                <a:off x="297283" y="266700"/>
                <a:ext cx="604653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8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a)</a:t>
                </a:r>
                <a:endParaRPr 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3028950" y="266700"/>
                <a:ext cx="625492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8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b)</a:t>
                </a:r>
                <a:endParaRPr 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6050379" y="266700"/>
                <a:ext cx="583814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8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c)</a:t>
                </a:r>
                <a:endParaRPr 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1" name="Group 20"/>
            <p:cNvGrpSpPr/>
            <p:nvPr/>
          </p:nvGrpSpPr>
          <p:grpSpPr>
            <a:xfrm>
              <a:off x="167518" y="3059256"/>
              <a:ext cx="6336538" cy="542270"/>
              <a:chOff x="167518" y="3059256"/>
              <a:chExt cx="6336538" cy="542270"/>
            </a:xfrm>
          </p:grpSpPr>
          <p:sp>
            <p:nvSpPr>
              <p:cNvPr id="22" name="TextBox 21"/>
              <p:cNvSpPr txBox="1"/>
              <p:nvPr/>
            </p:nvSpPr>
            <p:spPr>
              <a:xfrm>
                <a:off x="167518" y="3059256"/>
                <a:ext cx="625492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8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d)</a:t>
                </a:r>
                <a:endParaRPr 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3032535" y="3078306"/>
                <a:ext cx="583814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8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e)</a:t>
                </a:r>
                <a:endParaRPr 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5958714" y="3059256"/>
                <a:ext cx="545342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8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f)</a:t>
                </a:r>
                <a:endParaRPr 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9" name="Rectangle 28"/>
            <p:cNvSpPr/>
            <p:nvPr/>
          </p:nvSpPr>
          <p:spPr>
            <a:xfrm>
              <a:off x="76199" y="5836025"/>
              <a:ext cx="8893261" cy="1021975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just"/>
              <a:r>
                <a:rPr lang="en-US" sz="1600" b="1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5.</a:t>
              </a:r>
              <a:r>
                <a:rPr lang="en-US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ounter graph showing the interaction between </a:t>
              </a:r>
              <a:r>
                <a:rPr lang="en-US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xtract </a:t>
              </a:r>
              <a:r>
                <a:rPr lang="en-US" sz="1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oncentration and </a:t>
              </a:r>
              <a:r>
                <a:rPr lang="en-US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plenocyte </a:t>
              </a:r>
              <a:r>
                <a:rPr lang="en-US" sz="1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roliferation activity. </a:t>
              </a:r>
              <a:r>
                <a:rPr lang="en-US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nteraction between (a) </a:t>
              </a:r>
              <a:r>
                <a:rPr lang="en-US" sz="1600" i="1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. </a:t>
              </a:r>
              <a:r>
                <a:rPr lang="en-US" sz="1600" i="1" dirty="0" err="1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mblica</a:t>
              </a:r>
              <a:r>
                <a:rPr lang="en-US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and </a:t>
              </a:r>
              <a:r>
                <a:rPr lang="en-US" sz="1600" i="1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. </a:t>
              </a:r>
              <a:r>
                <a:rPr lang="en-US" sz="1600" i="1" dirty="0" err="1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igrum</a:t>
              </a:r>
              <a:r>
                <a:rPr lang="en-US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; (b) </a:t>
              </a:r>
              <a:r>
                <a:rPr lang="en-US" sz="1600" i="1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. </a:t>
              </a:r>
              <a:r>
                <a:rPr lang="en-US" sz="1600" i="1" dirty="0" err="1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mblica</a:t>
              </a:r>
              <a:r>
                <a:rPr lang="en-US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and </a:t>
              </a:r>
              <a:r>
                <a:rPr lang="en-US" sz="1600" i="1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W. </a:t>
              </a:r>
              <a:r>
                <a:rPr lang="en-US" sz="1600" i="1" dirty="0" err="1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omnifera</a:t>
              </a:r>
              <a:r>
                <a:rPr lang="en-US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; (c) </a:t>
              </a:r>
              <a:r>
                <a:rPr lang="en-US" sz="1600" i="1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. </a:t>
              </a:r>
              <a:r>
                <a:rPr lang="en-US" sz="1600" i="1" dirty="0" err="1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mblica</a:t>
              </a:r>
              <a:r>
                <a:rPr lang="en-US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and </a:t>
              </a:r>
              <a:r>
                <a:rPr lang="en-US" sz="1600" i="1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. </a:t>
              </a:r>
              <a:r>
                <a:rPr lang="en-US" sz="1600" i="1" dirty="0" err="1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ordifolia</a:t>
              </a:r>
              <a:r>
                <a:rPr lang="en-US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; (d) </a:t>
              </a:r>
              <a:r>
                <a:rPr lang="en-US" sz="1600" i="1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. </a:t>
              </a:r>
              <a:r>
                <a:rPr lang="en-US" sz="1600" i="1" dirty="0" err="1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igrum</a:t>
              </a:r>
              <a:r>
                <a:rPr lang="en-US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and </a:t>
              </a:r>
              <a:r>
                <a:rPr lang="en-US" sz="1600" i="1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W. </a:t>
              </a:r>
              <a:r>
                <a:rPr lang="en-US" sz="1600" i="1" dirty="0" err="1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omnifera</a:t>
              </a:r>
              <a:r>
                <a:rPr lang="en-US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; (e) </a:t>
              </a:r>
              <a:r>
                <a:rPr lang="en-US" sz="1600" i="1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. </a:t>
              </a:r>
              <a:r>
                <a:rPr lang="en-US" sz="1600" i="1" dirty="0" err="1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igrum</a:t>
              </a:r>
              <a:r>
                <a:rPr lang="en-US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and </a:t>
              </a:r>
              <a:r>
                <a:rPr lang="en-US" sz="1600" i="1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. </a:t>
              </a:r>
              <a:r>
                <a:rPr lang="en-US" sz="1600" i="1" dirty="0" err="1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ordifolia</a:t>
              </a:r>
              <a:r>
                <a:rPr lang="en-US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; (f) </a:t>
              </a:r>
              <a:r>
                <a:rPr lang="en-US" sz="1600" i="1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W. </a:t>
              </a:r>
              <a:r>
                <a:rPr lang="en-US" sz="1600" i="1" dirty="0" err="1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omnifera</a:t>
              </a:r>
              <a:r>
                <a:rPr lang="en-US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and </a:t>
              </a:r>
              <a:r>
                <a:rPr lang="en-US" sz="1600" i="1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. </a:t>
              </a:r>
              <a:r>
                <a:rPr lang="en-US" sz="1600" i="1" dirty="0" err="1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ordifolia</a:t>
              </a:r>
              <a:r>
                <a:rPr lang="en-US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endParaRPr lang="en-IN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Rectangle 29"/>
            <p:cNvSpPr/>
            <p:nvPr/>
          </p:nvSpPr>
          <p:spPr>
            <a:xfrm>
              <a:off x="76200" y="-1"/>
              <a:ext cx="8691282" cy="518705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IN" b="1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nteracting effect of extract concentration on </a:t>
              </a:r>
              <a:r>
                <a:rPr lang="en-IN" b="1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plenocyte </a:t>
              </a:r>
              <a:r>
                <a:rPr lang="en-IN" b="1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roliferation activity</a:t>
              </a:r>
              <a:r>
                <a:rPr lang="en-IN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en-IN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83354645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/>
        </p:nvGrpSpPr>
        <p:grpSpPr>
          <a:xfrm>
            <a:off x="76199" y="-1"/>
            <a:ext cx="8893261" cy="6817660"/>
            <a:chOff x="76199" y="-1"/>
            <a:chExt cx="8893261" cy="6817660"/>
          </a:xfrm>
        </p:grpSpPr>
        <p:grpSp>
          <p:nvGrpSpPr>
            <p:cNvPr id="10" name="Group 9"/>
            <p:cNvGrpSpPr/>
            <p:nvPr/>
          </p:nvGrpSpPr>
          <p:grpSpPr>
            <a:xfrm>
              <a:off x="76199" y="398748"/>
              <a:ext cx="8893261" cy="6418911"/>
              <a:chOff x="76199" y="398748"/>
              <a:chExt cx="8893261" cy="6418911"/>
            </a:xfrm>
          </p:grpSpPr>
          <p:grpSp>
            <p:nvGrpSpPr>
              <p:cNvPr id="17" name="Group 16"/>
              <p:cNvGrpSpPr/>
              <p:nvPr/>
            </p:nvGrpSpPr>
            <p:grpSpPr>
              <a:xfrm>
                <a:off x="412703" y="398748"/>
                <a:ext cx="6336910" cy="523220"/>
                <a:chOff x="297283" y="266700"/>
                <a:chExt cx="6336910" cy="523220"/>
              </a:xfrm>
            </p:grpSpPr>
            <p:sp>
              <p:nvSpPr>
                <p:cNvPr id="18" name="TextBox 17"/>
                <p:cNvSpPr txBox="1"/>
                <p:nvPr/>
              </p:nvSpPr>
              <p:spPr>
                <a:xfrm>
                  <a:off x="297283" y="266700"/>
                  <a:ext cx="604653" cy="523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2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(a)</a:t>
                  </a:r>
                  <a:endParaRPr lang="en-US" sz="2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" name="TextBox 18"/>
                <p:cNvSpPr txBox="1"/>
                <p:nvPr/>
              </p:nvSpPr>
              <p:spPr>
                <a:xfrm>
                  <a:off x="3028950" y="266700"/>
                  <a:ext cx="625492" cy="523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2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(b)</a:t>
                  </a:r>
                  <a:endParaRPr lang="en-US" sz="2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>
                  <a:off x="6050379" y="266700"/>
                  <a:ext cx="583814" cy="523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2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(c)</a:t>
                  </a:r>
                  <a:endParaRPr lang="en-US" sz="2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21" name="Group 20"/>
              <p:cNvGrpSpPr/>
              <p:nvPr/>
            </p:nvGrpSpPr>
            <p:grpSpPr>
              <a:xfrm>
                <a:off x="580558" y="2960591"/>
                <a:ext cx="6336538" cy="542270"/>
                <a:chOff x="167518" y="3059256"/>
                <a:chExt cx="6336538" cy="542270"/>
              </a:xfrm>
            </p:grpSpPr>
            <p:sp>
              <p:nvSpPr>
                <p:cNvPr id="22" name="TextBox 21"/>
                <p:cNvSpPr txBox="1"/>
                <p:nvPr/>
              </p:nvSpPr>
              <p:spPr>
                <a:xfrm>
                  <a:off x="167518" y="3059256"/>
                  <a:ext cx="625492" cy="523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2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(d)</a:t>
                  </a:r>
                  <a:endParaRPr lang="en-US" sz="2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" name="TextBox 22"/>
                <p:cNvSpPr txBox="1"/>
                <p:nvPr/>
              </p:nvSpPr>
              <p:spPr>
                <a:xfrm>
                  <a:off x="3032535" y="3078306"/>
                  <a:ext cx="583814" cy="523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2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(e)</a:t>
                  </a:r>
                  <a:endParaRPr lang="en-US" sz="2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" name="TextBox 23"/>
                <p:cNvSpPr txBox="1"/>
                <p:nvPr/>
              </p:nvSpPr>
              <p:spPr>
                <a:xfrm>
                  <a:off x="5958714" y="3059256"/>
                  <a:ext cx="545342" cy="523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2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(f)</a:t>
                  </a:r>
                  <a:endParaRPr lang="en-US" sz="2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8" name="Group 7"/>
              <p:cNvGrpSpPr/>
              <p:nvPr/>
            </p:nvGrpSpPr>
            <p:grpSpPr>
              <a:xfrm>
                <a:off x="278232" y="921968"/>
                <a:ext cx="8569183" cy="2159915"/>
                <a:chOff x="278232" y="599240"/>
                <a:chExt cx="8569183" cy="2159915"/>
              </a:xfrm>
            </p:grpSpPr>
            <p:pic>
              <p:nvPicPr>
                <p:cNvPr id="2" name="Picture 1"/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27850" t="4257" r="2367" b="3217"/>
                <a:stretch/>
              </p:blipFill>
              <p:spPr>
                <a:xfrm>
                  <a:off x="278232" y="599240"/>
                  <a:ext cx="2731667" cy="2159915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3" name="Picture 2"/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26691" t="3271" r="4039" b="3052"/>
                <a:stretch/>
              </p:blipFill>
              <p:spPr>
                <a:xfrm>
                  <a:off x="3187761" y="599240"/>
                  <a:ext cx="2731667" cy="2159915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4" name="Picture 3"/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27019" t="3619" r="3711" b="3144"/>
                <a:stretch/>
              </p:blipFill>
              <p:spPr>
                <a:xfrm>
                  <a:off x="6115748" y="599240"/>
                  <a:ext cx="2731667" cy="2159915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  <p:grpSp>
            <p:nvGrpSpPr>
              <p:cNvPr id="9" name="Group 8"/>
              <p:cNvGrpSpPr/>
              <p:nvPr/>
            </p:nvGrpSpPr>
            <p:grpSpPr>
              <a:xfrm>
                <a:off x="278232" y="3502861"/>
                <a:ext cx="8569183" cy="2159915"/>
                <a:chOff x="278232" y="3502861"/>
                <a:chExt cx="8569183" cy="2159915"/>
              </a:xfrm>
            </p:grpSpPr>
            <p:pic>
              <p:nvPicPr>
                <p:cNvPr id="5" name="Picture 4"/>
                <p:cNvPicPr>
                  <a:picLocks noChangeAspect="1"/>
                </p:cNvPicPr>
                <p:nvPr/>
              </p:nvPicPr>
              <p:blipFill rotWithShape="1">
                <a:blip r:embed="rId5"/>
                <a:srcRect l="27725" t="3619" r="4319" b="3144"/>
                <a:stretch/>
              </p:blipFill>
              <p:spPr>
                <a:xfrm>
                  <a:off x="278232" y="3502861"/>
                  <a:ext cx="2731667" cy="2159915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6" name="Picture 5"/>
                <p:cNvPicPr>
                  <a:picLocks noChangeAspect="1"/>
                </p:cNvPicPr>
                <p:nvPr/>
              </p:nvPicPr>
              <p:blipFill rotWithShape="1">
                <a:blip r:embed="rId6"/>
                <a:srcRect l="27309" t="4636" r="3422" b="3001"/>
                <a:stretch/>
              </p:blipFill>
              <p:spPr>
                <a:xfrm>
                  <a:off x="3187761" y="3502861"/>
                  <a:ext cx="2731667" cy="2159915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7" name="Picture 6"/>
                <p:cNvPicPr>
                  <a:picLocks noChangeAspect="1"/>
                </p:cNvPicPr>
                <p:nvPr/>
              </p:nvPicPr>
              <p:blipFill rotWithShape="1">
                <a:blip r:embed="rId7"/>
                <a:srcRect l="27226" t="3841" r="3504" b="2920"/>
                <a:stretch/>
              </p:blipFill>
              <p:spPr>
                <a:xfrm>
                  <a:off x="6115748" y="3502861"/>
                  <a:ext cx="2731667" cy="2159915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  <p:sp>
            <p:nvSpPr>
              <p:cNvPr id="26" name="Rectangle 25"/>
              <p:cNvSpPr/>
              <p:nvPr/>
            </p:nvSpPr>
            <p:spPr>
              <a:xfrm>
                <a:off x="76199" y="5795684"/>
                <a:ext cx="8893261" cy="1021975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just"/>
                <a:r>
                  <a:rPr lang="en-US" sz="1600" b="1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upplementary Figure </a:t>
                </a:r>
                <a:r>
                  <a:rPr lang="en-US" sz="16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</a:t>
                </a:r>
                <a:r>
                  <a:rPr lang="en-US" sz="1600" b="1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.</a:t>
                </a:r>
                <a:r>
                  <a:rPr lang="en-US" sz="16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unter graph showing the interaction between </a:t>
                </a:r>
                <a:r>
                  <a:rPr lang="en-US" sz="16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xtract </a:t>
                </a:r>
                <a:r>
                  <a:rPr lang="en-US" sz="1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centration and </a:t>
                </a:r>
                <a:r>
                  <a:rPr lang="en-US" sz="16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inocytic activity</a:t>
                </a:r>
                <a:r>
                  <a:rPr lang="en-US" sz="1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. </a:t>
                </a:r>
                <a:r>
                  <a:rPr lang="en-US" sz="16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teraction between (a) </a:t>
                </a:r>
                <a:r>
                  <a:rPr lang="en-US" sz="1600" i="1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. emblica</a:t>
                </a:r>
                <a:r>
                  <a:rPr lang="en-US" sz="16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and </a:t>
                </a:r>
                <a:r>
                  <a:rPr lang="en-US" sz="1600" i="1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. nigrum</a:t>
                </a:r>
                <a:r>
                  <a:rPr lang="en-US" sz="16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; (b) </a:t>
                </a:r>
                <a:r>
                  <a:rPr lang="en-US" sz="1600" i="1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. emblica</a:t>
                </a:r>
                <a:r>
                  <a:rPr lang="en-US" sz="16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and </a:t>
                </a:r>
                <a:r>
                  <a:rPr lang="en-US" sz="1600" i="1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. somnifera</a:t>
                </a:r>
                <a:r>
                  <a:rPr lang="en-US" sz="16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; (c) </a:t>
                </a:r>
                <a:r>
                  <a:rPr lang="en-US" sz="1600" i="1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. emblica</a:t>
                </a:r>
                <a:r>
                  <a:rPr lang="en-US" sz="16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and </a:t>
                </a:r>
                <a:r>
                  <a:rPr lang="en-US" sz="1600" i="1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. cordifolia</a:t>
                </a:r>
                <a:r>
                  <a:rPr lang="en-US" sz="16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; (d) </a:t>
                </a:r>
                <a:r>
                  <a:rPr lang="en-US" sz="1600" i="1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. nigrum</a:t>
                </a:r>
                <a:r>
                  <a:rPr lang="en-US" sz="16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and </a:t>
                </a:r>
                <a:r>
                  <a:rPr lang="en-US" sz="1600" i="1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. somnifera</a:t>
                </a:r>
                <a:r>
                  <a:rPr lang="en-US" sz="16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; (e) </a:t>
                </a:r>
                <a:r>
                  <a:rPr lang="en-US" sz="1600" i="1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. nigrum</a:t>
                </a:r>
                <a:r>
                  <a:rPr lang="en-US" sz="16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and </a:t>
                </a:r>
                <a:r>
                  <a:rPr lang="en-US" sz="1600" i="1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. cordifolia</a:t>
                </a:r>
                <a:r>
                  <a:rPr lang="en-US" sz="16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; (f) </a:t>
                </a:r>
                <a:r>
                  <a:rPr lang="en-US" sz="1600" i="1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. somnifera</a:t>
                </a:r>
                <a:r>
                  <a:rPr lang="en-US" sz="16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and </a:t>
                </a:r>
                <a:r>
                  <a:rPr lang="en-US" sz="1600" i="1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. cordifolia</a:t>
                </a:r>
                <a:r>
                  <a:rPr lang="en-US" sz="16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.</a:t>
                </a:r>
                <a:endParaRPr lang="en-IN" sz="1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7" name="Rectangle 26"/>
            <p:cNvSpPr/>
            <p:nvPr/>
          </p:nvSpPr>
          <p:spPr>
            <a:xfrm>
              <a:off x="76200" y="-1"/>
              <a:ext cx="8691282" cy="518705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IN" b="1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nteracting effect of extract concentration on pinocytic activity</a:t>
              </a:r>
              <a:endParaRPr lang="en-IN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9770817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0381" y="710335"/>
            <a:ext cx="8821451" cy="5314387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157391" y="61404"/>
            <a:ext cx="8815693" cy="595953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ructure </a:t>
            </a:r>
            <a:r>
              <a:rPr lang="en-US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f major </a:t>
            </a:r>
            <a:r>
              <a:rPr lang="en-US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tabolites identified by UPLC-MS</a:t>
            </a:r>
            <a:endParaRPr lang="en-IN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344798" y="6210425"/>
            <a:ext cx="8545609" cy="595953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r>
              <a:rPr lang="en-US" sz="16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6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sz="16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ructure </a:t>
            </a:r>
            <a:r>
              <a:rPr lang="en-US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f major metabolites </a:t>
            </a:r>
            <a:r>
              <a:rPr lang="en-US" sz="16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 extracts and combination</a:t>
            </a:r>
            <a:endParaRPr lang="en-IN" sz="16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8966851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256374" y="290557"/>
            <a:ext cx="8713086" cy="6366617"/>
            <a:chOff x="76199" y="-1"/>
            <a:chExt cx="8893261" cy="6858001"/>
          </a:xfrm>
        </p:grpSpPr>
        <p:sp>
          <p:nvSpPr>
            <p:cNvPr id="3" name="TextBox 2"/>
            <p:cNvSpPr txBox="1"/>
            <p:nvPr/>
          </p:nvSpPr>
          <p:spPr>
            <a:xfrm>
              <a:off x="1893760" y="5497471"/>
              <a:ext cx="578601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: </a:t>
              </a:r>
              <a:r>
                <a:rPr lang="en-US" sz="16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. emblica</a:t>
              </a:r>
              <a:r>
                <a:rPr lang="en-US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; B: </a:t>
              </a:r>
              <a:r>
                <a:rPr lang="en-US" sz="16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. cordifolia</a:t>
              </a:r>
              <a:r>
                <a:rPr lang="en-US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; C: </a:t>
              </a:r>
              <a:r>
                <a:rPr lang="en-US" sz="16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. somnifera</a:t>
              </a:r>
              <a:r>
                <a:rPr lang="en-US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; D: </a:t>
              </a:r>
              <a:r>
                <a:rPr lang="en-US" sz="16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. nigrum</a:t>
              </a:r>
              <a:endPara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" name="Group 1"/>
            <p:cNvGrpSpPr/>
            <p:nvPr/>
          </p:nvGrpSpPr>
          <p:grpSpPr>
            <a:xfrm>
              <a:off x="76199" y="1647760"/>
              <a:ext cx="8757400" cy="3634267"/>
              <a:chOff x="76199" y="372957"/>
              <a:chExt cx="8757400" cy="3634267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76199" y="372957"/>
                <a:ext cx="4340426" cy="363426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5" name="Picture 4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4533401" y="372957"/>
                <a:ext cx="4300198" cy="363426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sp>
          <p:nvSpPr>
            <p:cNvPr id="6" name="Rectangle 5"/>
            <p:cNvSpPr/>
            <p:nvPr/>
          </p:nvSpPr>
          <p:spPr>
            <a:xfrm>
              <a:off x="76199" y="5836025"/>
              <a:ext cx="8893261" cy="1021975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just"/>
              <a:r>
                <a:rPr lang="en-US" sz="1600" b="1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8: </a:t>
              </a:r>
              <a:r>
                <a:rPr lang="en-US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a) PCA-plot; (b) S-plot</a:t>
              </a:r>
              <a:r>
                <a:rPr lang="en-US" sz="1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 A: </a:t>
              </a:r>
              <a:r>
                <a:rPr lang="en-US" sz="1600" i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. emblica</a:t>
              </a:r>
              <a:r>
                <a:rPr lang="en-US" sz="1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; B: </a:t>
              </a:r>
              <a:r>
                <a:rPr lang="en-US" sz="1600" i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. cordifolia</a:t>
              </a:r>
              <a:r>
                <a:rPr lang="en-US" sz="1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; C: </a:t>
              </a:r>
              <a:r>
                <a:rPr lang="en-US" sz="1600" i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W. somnifera</a:t>
              </a:r>
              <a:r>
                <a:rPr lang="en-US" sz="1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; D: </a:t>
              </a:r>
              <a:r>
                <a:rPr lang="en-US" sz="1600" i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. </a:t>
              </a:r>
              <a:r>
                <a:rPr lang="en-US" sz="1600" i="1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igrum</a:t>
              </a:r>
              <a:r>
                <a:rPr lang="en-US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r>
                <a:rPr lang="en-IN" sz="16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en-IN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Rectangle 6"/>
            <p:cNvSpPr/>
            <p:nvPr/>
          </p:nvSpPr>
          <p:spPr>
            <a:xfrm>
              <a:off x="76200" y="-1"/>
              <a:ext cx="8691282" cy="927848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IN" b="1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tatistical analysis UPLC-MS data: </a:t>
              </a:r>
              <a:r>
                <a:rPr lang="en-IN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r>
                <a:rPr lang="en-IN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tabolites of four extract were clustered and due to differentiation among them, all are found in different quadrant. While, s-plot showing the metabolites causing differentiation.</a:t>
              </a:r>
              <a:endParaRPr lang="en-IN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608881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76</TotalTime>
  <Words>474</Words>
  <Application>Microsoft Office PowerPoint</Application>
  <PresentationFormat>On-screen Show (4:3)</PresentationFormat>
  <Paragraphs>37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shim khan</dc:creator>
  <cp:lastModifiedBy>DELL</cp:lastModifiedBy>
  <cp:revision>107</cp:revision>
  <dcterms:created xsi:type="dcterms:W3CDTF">2020-02-22T17:50:48Z</dcterms:created>
  <dcterms:modified xsi:type="dcterms:W3CDTF">2021-09-25T18:22:31Z</dcterms:modified>
</cp:coreProperties>
</file>